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4" d="100"/>
          <a:sy n="114" d="100"/>
        </p:scale>
        <p:origin x="414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323317-3824-48EE-9833-FB5D9BE1071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1A0FEF5-57B1-65CF-3114-0B39AB274C3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zh-CN"/>
              <a:t>Click to edit Master subtitle style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910E82-42B3-19CA-A533-C361285E7A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72BC9-1141-4859-9AE2-B3EC0712F49E}" type="datetimeFigureOut">
              <a:rPr lang="zh-CN" altLang="en-US" smtClean="0"/>
              <a:pPr/>
              <a:t>2024/1/2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935846-565D-C5A5-1077-24F3EF9B6B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5A25A8-FAB9-26D8-D1A9-98434D43F7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2C930-E748-4792-985D-BFA8888A954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61596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F58482-0027-63B1-A82D-5B72C8F236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0B3F384-D779-9FC5-D945-80042E1047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C023B8-4022-4727-1E68-3F1C22FCE6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72BC9-1141-4859-9AE2-B3EC0712F49E}" type="datetimeFigureOut">
              <a:rPr lang="zh-CN" altLang="en-US" smtClean="0"/>
              <a:pPr/>
              <a:t>2024/1/2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CF534D-484B-3312-96ED-9BDA515AAC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0FCB4D-50F0-9343-7E2B-8FD262EBB4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2C930-E748-4792-985D-BFA8888A954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629149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DA05D48-BD5A-56F3-57CE-E5FBE0F3CD1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C30A5AF-2BEF-8601-CB33-77BEBFEAEE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D640F4-DAA1-146F-DC88-1934EC146F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72BC9-1141-4859-9AE2-B3EC0712F49E}" type="datetimeFigureOut">
              <a:rPr lang="zh-CN" altLang="en-US" smtClean="0"/>
              <a:pPr/>
              <a:t>2024/1/2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D1E9ED-BE45-3340-5458-A9FBCF884A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806389-7D3E-E0B6-E9E8-D3DC44AB97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2C930-E748-4792-985D-BFA8888A954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55657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C50652-549C-D0B8-C04D-0F9A399C0B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B4817B0-5850-B68A-955A-C11C0BEEE1A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ACE953-1D5C-711C-3270-C9BEBD4DB8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72BC9-1141-4859-9AE2-B3EC0712F49E}" type="datetimeFigureOut">
              <a:rPr lang="zh-CN" altLang="en-US" smtClean="0"/>
              <a:pPr/>
              <a:t>2024/1/2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1742AA-9A30-CA79-B4EB-EAD5B84837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49B882-5A0C-CB91-5A09-2BA10657A9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2C930-E748-4792-985D-BFA8888A954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86362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6A1B1B-AC11-5BAE-0A15-E44C809AE3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4C3064-E280-55C5-F8D5-1260B6429C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DA5C09-533E-208B-34A6-97364A75F3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72BC9-1141-4859-9AE2-B3EC0712F49E}" type="datetimeFigureOut">
              <a:rPr lang="zh-CN" altLang="en-US" smtClean="0"/>
              <a:pPr/>
              <a:t>2024/1/2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069338-34B7-00CB-7313-5083E2DA63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3864C6-BC20-563F-25DF-D3A9851D04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2C930-E748-4792-985D-BFA8888A954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2301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D178BE-C299-A1BD-0755-5C8030C643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5A0760-4C9E-19AF-54FB-4401EFA5E2E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456B063-543D-8A37-44BF-A03F896990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1DF8C05-E718-A331-1FE6-D9DEA22049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72BC9-1141-4859-9AE2-B3EC0712F49E}" type="datetimeFigureOut">
              <a:rPr lang="zh-CN" altLang="en-US" smtClean="0"/>
              <a:pPr/>
              <a:t>2024/1/2</a:t>
            </a:fld>
            <a:endParaRPr lang="zh-CN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871E54-6614-FAB4-169B-06DF4C067C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0BAD1A-FCE5-9E92-F25D-3E0BBA0609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2C930-E748-4792-985D-BFA8888A954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83360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0F26C0-741D-5BA5-7DAA-013C6D8926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96F2812-7E37-CCAC-AE0A-8CA69C05BC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D63F7A1-5084-FD69-AF60-4240DD51B5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299E25E-B15E-9C3D-FD25-4A71B07EEB3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AA45BAD-6C7B-DB24-58D6-82A2467F88F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2DB9B5E-2543-B8F8-C328-D97D26AFF9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72BC9-1141-4859-9AE2-B3EC0712F49E}" type="datetimeFigureOut">
              <a:rPr lang="zh-CN" altLang="en-US" smtClean="0"/>
              <a:pPr/>
              <a:t>2024/1/2</a:t>
            </a:fld>
            <a:endParaRPr lang="zh-CN" alt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348ECFE-7FDF-C469-4319-9D73295E13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69264B3-6B32-CFE1-6660-3E8274C053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2C930-E748-4792-985D-BFA8888A954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42085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490B2B-9914-8FA2-FF07-3053F457E0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1EA7E19-439A-3225-6044-CB7FF2EBAA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72BC9-1141-4859-9AE2-B3EC0712F49E}" type="datetimeFigureOut">
              <a:rPr lang="zh-CN" altLang="en-US" smtClean="0"/>
              <a:pPr/>
              <a:t>2024/1/2</a:t>
            </a:fld>
            <a:endParaRPr lang="zh-CN" alt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5A3001A-F9BD-45AB-30D9-F0D6C6A6FA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8D79714-B016-2E4A-A0AC-E8C27C7EB3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2C930-E748-4792-985D-BFA8888A954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70177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4D892B4-EB33-697F-F2E5-324D1EAD0F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72BC9-1141-4859-9AE2-B3EC0712F49E}" type="datetimeFigureOut">
              <a:rPr lang="zh-CN" altLang="en-US" smtClean="0"/>
              <a:pPr/>
              <a:t>2024/1/2</a:t>
            </a:fld>
            <a:endParaRPr lang="zh-CN" alt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425192E-9BEE-9F00-7CC0-78F0BECEA1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24C06CF-2101-5A86-E346-96BC9FA4FB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2C930-E748-4792-985D-BFA8888A954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714023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7E30BA-3E91-C1E5-381E-22CF37609E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2B20DB-1B9E-06B6-3CAB-BBE723269FF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0AC37ED-AB14-39BA-0192-B29253E216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872700-D217-7D80-8B2E-DB569EE674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72BC9-1141-4859-9AE2-B3EC0712F49E}" type="datetimeFigureOut">
              <a:rPr lang="zh-CN" altLang="en-US" smtClean="0"/>
              <a:pPr/>
              <a:t>2024/1/2</a:t>
            </a:fld>
            <a:endParaRPr lang="zh-CN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DBDD01D-B1AA-76C8-45C3-ECD883FBD7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71814F0-2A6E-61B2-5D92-E65CAF1D17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2C930-E748-4792-985D-BFA8888A954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24835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BBEA94-7A3F-320D-25E9-EBDA1FFDEA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10C30C4-C60C-2B0A-E90C-6AEA5065BC2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B8E9EC4-1D15-1E9E-25BA-BF434ED1993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13366FF-ECCA-C6E3-A467-52DF04F684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72BC9-1141-4859-9AE2-B3EC0712F49E}" type="datetimeFigureOut">
              <a:rPr lang="zh-CN" altLang="en-US" smtClean="0"/>
              <a:pPr/>
              <a:t>2024/1/2</a:t>
            </a:fld>
            <a:endParaRPr lang="zh-CN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E624D6C-AF70-C876-456F-1CA6CF7208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F5E6173-A786-CFF1-C527-39646A7AE2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2C930-E748-4792-985D-BFA8888A954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87488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37E3877-BB0C-7B39-3AC6-1E9E74A924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7911A2-EA50-9C0D-D442-76D0DC110B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C739E7-BDEB-9A2F-4667-CB7389B5AD3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272BC9-1141-4859-9AE2-B3EC0712F49E}" type="datetimeFigureOut">
              <a:rPr lang="zh-CN" altLang="en-US" smtClean="0"/>
              <a:pPr/>
              <a:t>2024/1/2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E72F89-8D4A-038D-AA84-494E4A6DEC8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B6FFDB-85F3-6069-0428-A1A3B8B0797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02C930-E748-4792-985D-BFA8888A954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65273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690A2492-859F-B51E-4467-46D4223F38B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10184298"/>
              </p:ext>
            </p:extLst>
          </p:nvPr>
        </p:nvGraphicFramePr>
        <p:xfrm>
          <a:off x="2441046" y="1751955"/>
          <a:ext cx="5417081" cy="4372620"/>
        </p:xfrm>
        <a:graphic>
          <a:graphicData uri="http://schemas.openxmlformats.org/drawingml/2006/table">
            <a:tbl>
              <a:tblPr/>
              <a:tblGrid>
                <a:gridCol w="819624">
                  <a:extLst>
                    <a:ext uri="{9D8B030D-6E8A-4147-A177-3AD203B41FA5}">
                      <a16:colId xmlns:a16="http://schemas.microsoft.com/office/drawing/2014/main" val="3510975377"/>
                    </a:ext>
                  </a:extLst>
                </a:gridCol>
                <a:gridCol w="765398">
                  <a:extLst>
                    <a:ext uri="{9D8B030D-6E8A-4147-A177-3AD203B41FA5}">
                      <a16:colId xmlns:a16="http://schemas.microsoft.com/office/drawing/2014/main" val="3289414"/>
                    </a:ext>
                  </a:extLst>
                </a:gridCol>
                <a:gridCol w="1288882">
                  <a:extLst>
                    <a:ext uri="{9D8B030D-6E8A-4147-A177-3AD203B41FA5}">
                      <a16:colId xmlns:a16="http://schemas.microsoft.com/office/drawing/2014/main" val="1336722009"/>
                    </a:ext>
                  </a:extLst>
                </a:gridCol>
                <a:gridCol w="2543177">
                  <a:extLst>
                    <a:ext uri="{9D8B030D-6E8A-4147-A177-3AD203B41FA5}">
                      <a16:colId xmlns:a16="http://schemas.microsoft.com/office/drawing/2014/main" val="1074192619"/>
                    </a:ext>
                  </a:extLst>
                </a:gridCol>
              </a:tblGrid>
              <a:tr h="412698"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ntibody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lone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Fluorophore(s)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Vender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8728554"/>
                  </a:ext>
                </a:extLst>
              </a:tr>
              <a:tr h="272821"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D3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Oct3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acific Blue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ioLegend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38398294"/>
                  </a:ext>
                </a:extLst>
              </a:tr>
              <a:tr h="397690"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D3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Oct3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erCP-Cy5.5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ioLegend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9774504"/>
                  </a:ext>
                </a:extLst>
              </a:tr>
              <a:tr h="210118"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D4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K3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V510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ioLegend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0185892"/>
                  </a:ext>
                </a:extLst>
              </a:tr>
              <a:tr h="210118"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D8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RPA-T8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V711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ioLegend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2259427"/>
                  </a:ext>
                </a:extLst>
              </a:tr>
              <a:tr h="210118"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D8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RPA-T8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UV563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ioLegend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9251108"/>
                  </a:ext>
                </a:extLst>
              </a:tr>
              <a:tr h="210118"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D25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C96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V605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ioLegend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7223627"/>
                  </a:ext>
                </a:extLst>
              </a:tr>
              <a:tr h="272821"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D34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QBend10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PC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R&amp;D Systems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89029427"/>
                  </a:ext>
                </a:extLst>
              </a:tr>
              <a:tr h="228932"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D34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QBend10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E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R&amp;D Systems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12202563"/>
                  </a:ext>
                </a:extLst>
              </a:tr>
              <a:tr h="260911"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D45RA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H9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UV496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D Biosciences 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5207615"/>
                  </a:ext>
                </a:extLst>
              </a:tr>
              <a:tr h="210118"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IM3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F38-2E2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V711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ioLegend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7606425"/>
                  </a:ext>
                </a:extLst>
              </a:tr>
              <a:tr h="210118"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CR7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043H7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F594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ioLegend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7667636"/>
                  </a:ext>
                </a:extLst>
              </a:tr>
              <a:tr h="210118"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IGIT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15153G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V421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ioLegend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79299425"/>
                  </a:ext>
                </a:extLst>
              </a:tr>
              <a:tr h="210118"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AG3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1C3C65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E-Cy7 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ioLegend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8708604"/>
                  </a:ext>
                </a:extLst>
              </a:tr>
              <a:tr h="273122"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D-1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EH12.1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V786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D Biosciences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8368973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NF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Mab11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E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D Biosciences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9709787"/>
                  </a:ext>
                </a:extLst>
              </a:tr>
              <a:tr h="261943"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IFNg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S.B3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E-Cy7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hermo Fisher Scientific</a:t>
                      </a:r>
                    </a:p>
                  </a:txBody>
                  <a:tcPr marL="7938" marR="7938" marT="793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28028895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F01F3A9A-338D-0726-369F-22DFF5CFEC42}"/>
              </a:ext>
            </a:extLst>
          </p:cNvPr>
          <p:cNvSpPr txBox="1"/>
          <p:nvPr/>
        </p:nvSpPr>
        <p:spPr>
          <a:xfrm>
            <a:off x="2441046" y="1105624"/>
            <a:ext cx="417293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n-NO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S1</a:t>
            </a:r>
          </a:p>
          <a:p>
            <a:r>
              <a:rPr lang="nn-NO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ntibodies usaed in Flow Cytometry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48023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</TotalTime>
  <Words>93</Words>
  <Application>Microsoft Office PowerPoint</Application>
  <PresentationFormat>Widescreen</PresentationFormat>
  <Paragraphs>7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ixin Jin</dc:creator>
  <cp:lastModifiedBy>MDPI</cp:lastModifiedBy>
  <cp:revision>7</cp:revision>
  <dcterms:created xsi:type="dcterms:W3CDTF">2023-11-04T12:33:53Z</dcterms:created>
  <dcterms:modified xsi:type="dcterms:W3CDTF">2024-01-02T01:44:47Z</dcterms:modified>
</cp:coreProperties>
</file>